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63" r:id="rId2"/>
    <p:sldId id="270" r:id="rId3"/>
    <p:sldId id="272" r:id="rId4"/>
    <p:sldId id="271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DFE9A"/>
    <a:srgbClr val="FFC0C0"/>
    <a:srgbClr val="CFD5EA"/>
    <a:srgbClr val="4472C4"/>
    <a:srgbClr val="F0F0F0"/>
    <a:srgbClr val="0000F7"/>
    <a:srgbClr val="7B78E5"/>
    <a:srgbClr val="04BC06"/>
    <a:srgbClr val="C5FD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5120" autoAdjust="0"/>
  </p:normalViewPr>
  <p:slideViewPr>
    <p:cSldViewPr snapToGrid="0">
      <p:cViewPr varScale="1">
        <p:scale>
          <a:sx n="57" d="100"/>
          <a:sy n="57" d="100"/>
        </p:scale>
        <p:origin x="2412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317FB-B3FC-425C-BCF1-281C901208BC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85CD2-F343-4482-AFD8-86D71839E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3951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317FB-B3FC-425C-BCF1-281C901208BC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85CD2-F343-4482-AFD8-86D71839E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965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317FB-B3FC-425C-BCF1-281C901208BC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85CD2-F343-4482-AFD8-86D71839E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2297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317FB-B3FC-425C-BCF1-281C901208BC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85CD2-F343-4482-AFD8-86D71839E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317FB-B3FC-425C-BCF1-281C901208BC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85CD2-F343-4482-AFD8-86D71839E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652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317FB-B3FC-425C-BCF1-281C901208BC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85CD2-F343-4482-AFD8-86D71839E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250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317FB-B3FC-425C-BCF1-281C901208BC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85CD2-F343-4482-AFD8-86D71839E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0434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317FB-B3FC-425C-BCF1-281C901208BC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85CD2-F343-4482-AFD8-86D71839E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276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317FB-B3FC-425C-BCF1-281C901208BC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85CD2-F343-4482-AFD8-86D71839E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366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317FB-B3FC-425C-BCF1-281C901208BC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85CD2-F343-4482-AFD8-86D71839E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693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317FB-B3FC-425C-BCF1-281C901208BC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85CD2-F343-4482-AFD8-86D71839E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452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3317FB-B3FC-425C-BCF1-281C901208BC}" type="datetimeFigureOut">
              <a:rPr lang="en-US" smtClean="0"/>
              <a:t>12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85CD2-F343-4482-AFD8-86D71839E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269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pn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11" Type="http://schemas.openxmlformats.org/officeDocument/2006/relationships/image" Target="../media/image10.png"/><Relationship Id="rId5" Type="http://schemas.openxmlformats.org/officeDocument/2006/relationships/image" Target="../media/image4.jpg"/><Relationship Id="rId10" Type="http://schemas.openxmlformats.org/officeDocument/2006/relationships/image" Target="../media/image9.pn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BFF888-BC2D-4299-AED3-2F0944DD08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1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s</a:t>
            </a:r>
            <a:b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plementation of Automated Behavior Metrics to Evaluate Voluntary Wheel Running Effects on Inflammatory-Erosive Arthritis and Interstitial Lung Disease in TNF-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g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DC7342-7512-44D2-BA00-44BEF8921E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10000"/>
          </a:bodyPr>
          <a:lstStyle/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buNone/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. Mark Kenney PhD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Ronald W. Wood PhD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5,6,7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Gabriel Ramirez MS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Richard D. Bell PhD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Kiana L. Chen MS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Lindsay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chnur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S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omaira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ahimi MD MTR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8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Benjamin D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orman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D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9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anping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Xing PhD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hristopher T.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itchlin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D MPH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9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dward M. Schwarz PhD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,3,7,9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Calvin L. </a:t>
            </a:r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e PhD</a:t>
            </a:r>
            <a:r>
              <a:rPr lang="en-US" sz="1800" baseline="300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3,4,*</a:t>
            </a:r>
            <a:endParaRPr lang="en-US" sz="18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nter for Musculoskeletal Research, 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Pathology &amp; Laboratory Medicine, 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Orthopaedics, 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Surgery,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5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Obstetrics and Gynecology, 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Neuroscience, 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Urology, 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8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Pediatrics, Pediatric Rheumatology, 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9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Medicine, Division of Allergy, Immunology, Rheumatology, University of Rochester Medical Center, Rochester, NY, USA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Research; Hospital for Special Surgery, New York, NY, USA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  <a:tabLst>
                <a:tab pos="1760220" algn="l"/>
              </a:tabLs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ing Author	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23970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70">
            <a:extLst>
              <a:ext uri="{FF2B5EF4-FFF2-40B4-BE49-F238E27FC236}">
                <a16:creationId xmlns:a16="http://schemas.microsoft.com/office/drawing/2014/main" id="{6ECA417D-CB90-0F65-323A-A39443E5564E}"/>
              </a:ext>
            </a:extLst>
          </p:cNvPr>
          <p:cNvSpPr txBox="1">
            <a:spLocks noChangeArrowheads="1"/>
          </p:cNvSpPr>
          <p:nvPr/>
        </p:nvSpPr>
        <p:spPr bwMode="auto">
          <a:xfrm rot="5400000">
            <a:off x="6569748" y="2556205"/>
            <a:ext cx="1574263" cy="2492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/>
            <a:r>
              <a:rPr lang="en-US" altLang="en-US" sz="1020" b="1" dirty="0">
                <a:solidFill>
                  <a:srgbClr val="FFFF00"/>
                </a:solidFill>
                <a:cs typeface="Arial" panose="020B0604020202020204" pitchFamily="34" charset="0"/>
              </a:rPr>
              <a:t>Aerated</a:t>
            </a:r>
            <a:r>
              <a:rPr lang="en-US" altLang="en-US" sz="1020" b="1" dirty="0">
                <a:solidFill>
                  <a:schemeClr val="bg1"/>
                </a:solidFill>
                <a:cs typeface="Arial" panose="020B0604020202020204" pitchFamily="34" charset="0"/>
              </a:rPr>
              <a:t>,</a:t>
            </a:r>
            <a:r>
              <a:rPr lang="en-US" altLang="en-US" sz="1020" b="1" dirty="0">
                <a:cs typeface="Arial" panose="020B0604020202020204" pitchFamily="34" charset="0"/>
              </a:rPr>
              <a:t> </a:t>
            </a:r>
            <a:r>
              <a:rPr lang="en-US" altLang="en-US" sz="1020" b="1" dirty="0">
                <a:solidFill>
                  <a:srgbClr val="00B0F0"/>
                </a:solidFill>
                <a:cs typeface="Arial" panose="020B0604020202020204" pitchFamily="34" charset="0"/>
              </a:rPr>
              <a:t>Tissue</a:t>
            </a:r>
          </a:p>
        </p:txBody>
      </p:sp>
      <p:sp>
        <p:nvSpPr>
          <p:cNvPr id="7" name="TextBox 70">
            <a:extLst>
              <a:ext uri="{FF2B5EF4-FFF2-40B4-BE49-F238E27FC236}">
                <a16:creationId xmlns:a16="http://schemas.microsoft.com/office/drawing/2014/main" id="{E456EC00-863D-F6CD-6310-24C2662F6EC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110623" y="1727092"/>
            <a:ext cx="1256016" cy="2492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/>
            <a:r>
              <a:rPr lang="en-US" altLang="en-US" sz="1020" b="1" dirty="0">
                <a:cs typeface="Arial" panose="020B0604020202020204" pitchFamily="34" charset="0"/>
              </a:rPr>
              <a:t>Sedentary</a:t>
            </a:r>
          </a:p>
        </p:txBody>
      </p:sp>
      <p:sp>
        <p:nvSpPr>
          <p:cNvPr id="8" name="TextBox 70">
            <a:extLst>
              <a:ext uri="{FF2B5EF4-FFF2-40B4-BE49-F238E27FC236}">
                <a16:creationId xmlns:a16="http://schemas.microsoft.com/office/drawing/2014/main" id="{0525AE9E-DCA8-0B56-69D9-5E27A3C548D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110622" y="3370897"/>
            <a:ext cx="1256016" cy="2492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/>
            <a:r>
              <a:rPr lang="en-US" altLang="en-US" sz="1020" b="1" dirty="0">
                <a:cs typeface="Arial" panose="020B0604020202020204" pitchFamily="34" charset="0"/>
              </a:rPr>
              <a:t>Run</a:t>
            </a:r>
          </a:p>
        </p:txBody>
      </p:sp>
      <p:sp>
        <p:nvSpPr>
          <p:cNvPr id="11" name="TextBox 70">
            <a:extLst>
              <a:ext uri="{FF2B5EF4-FFF2-40B4-BE49-F238E27FC236}">
                <a16:creationId xmlns:a16="http://schemas.microsoft.com/office/drawing/2014/main" id="{BB65D801-4DC5-053F-94C8-A886C1A269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45136" y="730463"/>
            <a:ext cx="1256016" cy="2492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/>
            <a:r>
              <a:rPr lang="en-US" altLang="en-US" sz="1020" b="1" dirty="0">
                <a:cs typeface="Arial" panose="020B0604020202020204" pitchFamily="34" charset="0"/>
              </a:rPr>
              <a:t>TNF-</a:t>
            </a:r>
            <a:r>
              <a:rPr lang="en-US" altLang="en-US" sz="1020" b="1" dirty="0" err="1">
                <a:cs typeface="Arial" panose="020B0604020202020204" pitchFamily="34" charset="0"/>
              </a:rPr>
              <a:t>Tg</a:t>
            </a:r>
            <a:endParaRPr lang="en-US" altLang="en-US" sz="1020" b="1" dirty="0"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BEDBCB4-A974-3107-0C22-CB49417C4B3E}"/>
              </a:ext>
            </a:extLst>
          </p:cNvPr>
          <p:cNvCxnSpPr/>
          <p:nvPr/>
        </p:nvCxnSpPr>
        <p:spPr>
          <a:xfrm>
            <a:off x="3982888" y="1000801"/>
            <a:ext cx="3219803" cy="0"/>
          </a:xfrm>
          <a:prstGeom prst="line">
            <a:avLst/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70">
            <a:extLst>
              <a:ext uri="{FF2B5EF4-FFF2-40B4-BE49-F238E27FC236}">
                <a16:creationId xmlns:a16="http://schemas.microsoft.com/office/drawing/2014/main" id="{47229529-7094-8B3D-C460-AB077F529C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89873" y="730463"/>
            <a:ext cx="1256016" cy="2492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/>
            <a:r>
              <a:rPr lang="en-US" altLang="en-US" sz="1020" b="1" dirty="0">
                <a:cs typeface="Arial" panose="020B0604020202020204" pitchFamily="34" charset="0"/>
              </a:rPr>
              <a:t>Wild-Type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AAEDFD1F-3D8C-1AB4-1CF0-EF26D3D36069}"/>
              </a:ext>
            </a:extLst>
          </p:cNvPr>
          <p:cNvCxnSpPr/>
          <p:nvPr/>
        </p:nvCxnSpPr>
        <p:spPr>
          <a:xfrm>
            <a:off x="727625" y="1000801"/>
            <a:ext cx="3219803" cy="0"/>
          </a:xfrm>
          <a:prstGeom prst="line">
            <a:avLst/>
          </a:prstGeom>
          <a:ln w="28575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70">
            <a:extLst>
              <a:ext uri="{FF2B5EF4-FFF2-40B4-BE49-F238E27FC236}">
                <a16:creationId xmlns:a16="http://schemas.microsoft.com/office/drawing/2014/main" id="{EDB72A5F-EF2A-C7E4-C4AB-EBB851F17A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51022" y="597740"/>
            <a:ext cx="1924691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/>
            <a:r>
              <a:rPr lang="en-US" altLang="en-US" sz="1050" b="1" u="sng" dirty="0">
                <a:cs typeface="Arial" panose="020B0604020202020204" pitchFamily="34" charset="0"/>
              </a:rPr>
              <a:t>Lung Micro-CT: Males</a:t>
            </a:r>
          </a:p>
        </p:txBody>
      </p:sp>
      <p:pic>
        <p:nvPicPr>
          <p:cNvPr id="21" name="Picture 20" descr="A close-up of a baby&#10;&#10;Description automatically generated with low confidence">
            <a:extLst>
              <a:ext uri="{FF2B5EF4-FFF2-40B4-BE49-F238E27FC236}">
                <a16:creationId xmlns:a16="http://schemas.microsoft.com/office/drawing/2014/main" id="{2FF624ED-5775-DBB7-CBEA-F54E72EEA17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06" r="10106"/>
          <a:stretch/>
        </p:blipFill>
        <p:spPr>
          <a:xfrm rot="5400000">
            <a:off x="725059" y="2688314"/>
            <a:ext cx="1574263" cy="1574263"/>
          </a:xfrm>
          <a:prstGeom prst="rect">
            <a:avLst/>
          </a:prstGeom>
        </p:spPr>
      </p:pic>
      <p:pic>
        <p:nvPicPr>
          <p:cNvPr id="23" name="Picture 22" descr="A picture containing close&#10;&#10;Description automatically generated">
            <a:extLst>
              <a:ext uri="{FF2B5EF4-FFF2-40B4-BE49-F238E27FC236}">
                <a16:creationId xmlns:a16="http://schemas.microsoft.com/office/drawing/2014/main" id="{FB31AB91-CFCC-A6C9-C8C6-6603614647B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59" r="10359"/>
          <a:stretch/>
        </p:blipFill>
        <p:spPr>
          <a:xfrm rot="5400000">
            <a:off x="2341687" y="2688314"/>
            <a:ext cx="1574263" cy="1574263"/>
          </a:xfrm>
          <a:prstGeom prst="rect">
            <a:avLst/>
          </a:prstGeom>
        </p:spPr>
      </p:pic>
      <p:pic>
        <p:nvPicPr>
          <p:cNvPr id="25" name="Picture 24" descr="A close-up of a fetus&#10;&#10;Description automatically generated with medium confidence">
            <a:extLst>
              <a:ext uri="{FF2B5EF4-FFF2-40B4-BE49-F238E27FC236}">
                <a16:creationId xmlns:a16="http://schemas.microsoft.com/office/drawing/2014/main" id="{59B70853-6339-8066-8905-130BEFDC7CD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35" r="12435"/>
          <a:stretch/>
        </p:blipFill>
        <p:spPr>
          <a:xfrm rot="5400000">
            <a:off x="4013367" y="2688314"/>
            <a:ext cx="1574263" cy="1574263"/>
          </a:xfrm>
          <a:prstGeom prst="rect">
            <a:avLst/>
          </a:prstGeom>
        </p:spPr>
      </p:pic>
      <p:pic>
        <p:nvPicPr>
          <p:cNvPr id="27" name="Picture 26" descr="A picture containing text&#10;&#10;Description automatically generated">
            <a:extLst>
              <a:ext uri="{FF2B5EF4-FFF2-40B4-BE49-F238E27FC236}">
                <a16:creationId xmlns:a16="http://schemas.microsoft.com/office/drawing/2014/main" id="{7CE22304-9554-EA41-DE4F-1741AD2C511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13" r="12513"/>
          <a:stretch/>
        </p:blipFill>
        <p:spPr>
          <a:xfrm rot="5400000">
            <a:off x="5632269" y="2680854"/>
            <a:ext cx="1574263" cy="1574263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B8AE2DC2-C64B-DB9D-4403-D10C49F7866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76" b="3276"/>
          <a:stretch/>
        </p:blipFill>
        <p:spPr>
          <a:xfrm>
            <a:off x="727333" y="1065746"/>
            <a:ext cx="1571989" cy="1571989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EAE26AB4-AB3C-393F-410D-B8583B70BEA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18" b="3218"/>
          <a:stretch/>
        </p:blipFill>
        <p:spPr>
          <a:xfrm>
            <a:off x="2343962" y="1065746"/>
            <a:ext cx="1571989" cy="1571989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C443F4A4-8A9A-3273-0E41-9F16DFAD8EF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61" b="3061"/>
          <a:stretch/>
        </p:blipFill>
        <p:spPr>
          <a:xfrm>
            <a:off x="4023330" y="1065746"/>
            <a:ext cx="1571989" cy="1571989"/>
          </a:xfrm>
          <a:prstGeom prst="rect">
            <a:avLst/>
          </a:prstGeom>
        </p:spPr>
      </p:pic>
      <p:pic>
        <p:nvPicPr>
          <p:cNvPr id="39" name="Picture 38" descr="A picture containing close&#10;&#10;Description automatically generated">
            <a:extLst>
              <a:ext uri="{FF2B5EF4-FFF2-40B4-BE49-F238E27FC236}">
                <a16:creationId xmlns:a16="http://schemas.microsoft.com/office/drawing/2014/main" id="{B9080B98-08E8-3E15-4AD3-FFC59D796D89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20" b="3220"/>
          <a:stretch/>
        </p:blipFill>
        <p:spPr>
          <a:xfrm>
            <a:off x="5632269" y="1065746"/>
            <a:ext cx="1571987" cy="1571987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33A7BD98-BF70-8E31-65C5-55614E930AE6}"/>
              </a:ext>
            </a:extLst>
          </p:cNvPr>
          <p:cNvSpPr txBox="1"/>
          <p:nvPr/>
        </p:nvSpPr>
        <p:spPr>
          <a:xfrm>
            <a:off x="1744991" y="979762"/>
            <a:ext cx="606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err="1">
                <a:solidFill>
                  <a:schemeClr val="bg1"/>
                </a:solidFill>
              </a:rPr>
              <a:t>A.a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1E6C3BB-99F2-E5FB-DA92-D3654971392D}"/>
              </a:ext>
            </a:extLst>
          </p:cNvPr>
          <p:cNvSpPr txBox="1"/>
          <p:nvPr/>
        </p:nvSpPr>
        <p:spPr>
          <a:xfrm>
            <a:off x="3362743" y="979761"/>
            <a:ext cx="6197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err="1">
                <a:solidFill>
                  <a:schemeClr val="bg1"/>
                </a:solidFill>
              </a:rPr>
              <a:t>A.b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A649BA6-09F5-DABA-4DF1-92E32B09DF57}"/>
              </a:ext>
            </a:extLst>
          </p:cNvPr>
          <p:cNvSpPr txBox="1"/>
          <p:nvPr/>
        </p:nvSpPr>
        <p:spPr>
          <a:xfrm>
            <a:off x="1720286" y="2636705"/>
            <a:ext cx="5918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err="1">
                <a:solidFill>
                  <a:schemeClr val="bg1"/>
                </a:solidFill>
              </a:rPr>
              <a:t>B.a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C99DAC9-C2B3-0603-35A1-0C1B95D1018C}"/>
              </a:ext>
            </a:extLst>
          </p:cNvPr>
          <p:cNvSpPr txBox="1"/>
          <p:nvPr/>
        </p:nvSpPr>
        <p:spPr>
          <a:xfrm>
            <a:off x="3359462" y="2636705"/>
            <a:ext cx="6046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err="1">
                <a:solidFill>
                  <a:schemeClr val="bg1"/>
                </a:solidFill>
              </a:rPr>
              <a:t>B.b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C2C3C80-22E8-B8AF-9625-0AF92927E6E3}"/>
              </a:ext>
            </a:extLst>
          </p:cNvPr>
          <p:cNvSpPr txBox="1"/>
          <p:nvPr/>
        </p:nvSpPr>
        <p:spPr>
          <a:xfrm>
            <a:off x="5049881" y="1000801"/>
            <a:ext cx="5822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err="1">
                <a:solidFill>
                  <a:schemeClr val="bg1"/>
                </a:solidFill>
              </a:rPr>
              <a:t>C.a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8A4853E-5800-1B9E-C4C4-81ED9EF0E4B5}"/>
              </a:ext>
            </a:extLst>
          </p:cNvPr>
          <p:cNvSpPr txBox="1"/>
          <p:nvPr/>
        </p:nvSpPr>
        <p:spPr>
          <a:xfrm>
            <a:off x="6655015" y="1000801"/>
            <a:ext cx="595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err="1">
                <a:solidFill>
                  <a:schemeClr val="bg1"/>
                </a:solidFill>
              </a:rPr>
              <a:t>C.b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CAF0598-E2F3-6267-19B9-CB2BF941877D}"/>
              </a:ext>
            </a:extLst>
          </p:cNvPr>
          <p:cNvSpPr txBox="1"/>
          <p:nvPr/>
        </p:nvSpPr>
        <p:spPr>
          <a:xfrm>
            <a:off x="5019966" y="2607324"/>
            <a:ext cx="6059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err="1">
                <a:solidFill>
                  <a:schemeClr val="bg1"/>
                </a:solidFill>
              </a:rPr>
              <a:t>D.a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1AB9F90-A4CF-221F-02DC-37F5F0D22211}"/>
              </a:ext>
            </a:extLst>
          </p:cNvPr>
          <p:cNvSpPr txBox="1"/>
          <p:nvPr/>
        </p:nvSpPr>
        <p:spPr>
          <a:xfrm>
            <a:off x="6651170" y="2607325"/>
            <a:ext cx="6187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err="1">
                <a:solidFill>
                  <a:schemeClr val="bg1"/>
                </a:solidFill>
              </a:rPr>
              <a:t>D.b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5EDBD4C-C6B5-C12A-E006-03C687A1FD9A}"/>
              </a:ext>
            </a:extLst>
          </p:cNvPr>
          <p:cNvSpPr txBox="1"/>
          <p:nvPr/>
        </p:nvSpPr>
        <p:spPr>
          <a:xfrm>
            <a:off x="-6723" y="-6708"/>
            <a:ext cx="1579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Supplementary Figure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B861B91-C6A3-4488-A269-DB1671C2C7EC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" b="5311"/>
          <a:stretch/>
        </p:blipFill>
        <p:spPr>
          <a:xfrm>
            <a:off x="4017367" y="6211732"/>
            <a:ext cx="3155904" cy="166841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B03A686-2E67-0CF7-B28A-C91EABD455DC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b="5312"/>
          <a:stretch/>
        </p:blipFill>
        <p:spPr>
          <a:xfrm>
            <a:off x="722287" y="6211732"/>
            <a:ext cx="3155909" cy="166841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ADAEA28-2D5E-5314-3C30-028CE18FE64B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b="5312"/>
          <a:stretch/>
        </p:blipFill>
        <p:spPr>
          <a:xfrm>
            <a:off x="721367" y="4493534"/>
            <a:ext cx="3155909" cy="166841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4185097-F926-B71B-96A0-616062666A3C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1" b="5311"/>
          <a:stretch/>
        </p:blipFill>
        <p:spPr>
          <a:xfrm>
            <a:off x="4014724" y="4493535"/>
            <a:ext cx="3155904" cy="1668418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EF3AA70D-31CD-45FA-078E-1ADA7FD8C453}"/>
              </a:ext>
            </a:extLst>
          </p:cNvPr>
          <p:cNvSpPr txBox="1"/>
          <p:nvPr/>
        </p:nvSpPr>
        <p:spPr>
          <a:xfrm>
            <a:off x="1694919" y="4238139"/>
            <a:ext cx="9386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edentary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F3481FC-FB2F-DB7A-70BB-D8212B3CB396}"/>
              </a:ext>
            </a:extLst>
          </p:cNvPr>
          <p:cNvSpPr txBox="1"/>
          <p:nvPr/>
        </p:nvSpPr>
        <p:spPr>
          <a:xfrm>
            <a:off x="5398307" y="4250464"/>
            <a:ext cx="4780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Ru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D0C0380-9032-41F0-791E-5A454CC2AEEC}"/>
              </a:ext>
            </a:extLst>
          </p:cNvPr>
          <p:cNvSpPr txBox="1"/>
          <p:nvPr/>
        </p:nvSpPr>
        <p:spPr>
          <a:xfrm rot="16200000">
            <a:off x="318272" y="5306502"/>
            <a:ext cx="4667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10X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5E2095F-5630-D966-62C9-BA48026F56A2}"/>
              </a:ext>
            </a:extLst>
          </p:cNvPr>
          <p:cNvSpPr txBox="1"/>
          <p:nvPr/>
        </p:nvSpPr>
        <p:spPr>
          <a:xfrm rot="16200000">
            <a:off x="273119" y="6923089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100X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EC121269-B19B-713E-C5D0-6BB72BF0FBE5}"/>
              </a:ext>
            </a:extLst>
          </p:cNvPr>
          <p:cNvCxnSpPr>
            <a:cxnSpLocks/>
          </p:cNvCxnSpPr>
          <p:nvPr/>
        </p:nvCxnSpPr>
        <p:spPr>
          <a:xfrm>
            <a:off x="3627598" y="6102209"/>
            <a:ext cx="201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id="{9447AB3B-A181-738F-E957-B8705A63A19C}"/>
              </a:ext>
            </a:extLst>
          </p:cNvPr>
          <p:cNvSpPr/>
          <p:nvPr/>
        </p:nvSpPr>
        <p:spPr>
          <a:xfrm>
            <a:off x="2277502" y="5300513"/>
            <a:ext cx="148771" cy="12409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3A6DA8C0-07B0-6E36-8441-E48F5A104FC6}"/>
              </a:ext>
            </a:extLst>
          </p:cNvPr>
          <p:cNvCxnSpPr>
            <a:cxnSpLocks/>
          </p:cNvCxnSpPr>
          <p:nvPr/>
        </p:nvCxnSpPr>
        <p:spPr>
          <a:xfrm>
            <a:off x="6936583" y="6123164"/>
            <a:ext cx="201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53FB2866-5D4B-D076-2C88-387340AAEC6E}"/>
              </a:ext>
            </a:extLst>
          </p:cNvPr>
          <p:cNvCxnSpPr>
            <a:cxnSpLocks/>
          </p:cNvCxnSpPr>
          <p:nvPr/>
        </p:nvCxnSpPr>
        <p:spPr>
          <a:xfrm>
            <a:off x="6948682" y="7827416"/>
            <a:ext cx="201168" cy="0"/>
          </a:xfrm>
          <a:prstGeom prst="line">
            <a:avLst/>
          </a:prstGeom>
          <a:ln w="1905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4BCBE24-C241-C61A-469C-7F842F9A76E3}"/>
              </a:ext>
            </a:extLst>
          </p:cNvPr>
          <p:cNvCxnSpPr>
            <a:cxnSpLocks/>
          </p:cNvCxnSpPr>
          <p:nvPr/>
        </p:nvCxnSpPr>
        <p:spPr>
          <a:xfrm>
            <a:off x="3671062" y="7842656"/>
            <a:ext cx="201168" cy="0"/>
          </a:xfrm>
          <a:prstGeom prst="line">
            <a:avLst/>
          </a:prstGeom>
          <a:ln w="1905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DE4C0507-4500-09AE-CF10-DFDB87F8357C}"/>
              </a:ext>
            </a:extLst>
          </p:cNvPr>
          <p:cNvCxnSpPr>
            <a:cxnSpLocks/>
          </p:cNvCxnSpPr>
          <p:nvPr/>
        </p:nvCxnSpPr>
        <p:spPr>
          <a:xfrm flipH="1">
            <a:off x="2759558" y="6860661"/>
            <a:ext cx="520852" cy="216316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B1942918-9DA4-040E-B399-4FDFFF099C42}"/>
              </a:ext>
            </a:extLst>
          </p:cNvPr>
          <p:cNvCxnSpPr>
            <a:cxnSpLocks/>
          </p:cNvCxnSpPr>
          <p:nvPr/>
        </p:nvCxnSpPr>
        <p:spPr>
          <a:xfrm>
            <a:off x="5288532" y="6640274"/>
            <a:ext cx="343737" cy="405667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50">
            <a:extLst>
              <a:ext uri="{FF2B5EF4-FFF2-40B4-BE49-F238E27FC236}">
                <a16:creationId xmlns:a16="http://schemas.microsoft.com/office/drawing/2014/main" id="{891E3903-2075-8AEE-5838-837DB1DA93A0}"/>
              </a:ext>
            </a:extLst>
          </p:cNvPr>
          <p:cNvSpPr/>
          <p:nvPr/>
        </p:nvSpPr>
        <p:spPr>
          <a:xfrm>
            <a:off x="5049881" y="5344455"/>
            <a:ext cx="148771" cy="124098"/>
          </a:xfrm>
          <a:prstGeom prst="rect">
            <a:avLst/>
          </a:prstGeom>
          <a:noFill/>
          <a:ln w="19050"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3A8AE3A-8A4A-53AA-3EFB-B7A137E69ACC}"/>
              </a:ext>
            </a:extLst>
          </p:cNvPr>
          <p:cNvSpPr txBox="1"/>
          <p:nvPr/>
        </p:nvSpPr>
        <p:spPr>
          <a:xfrm>
            <a:off x="705558" y="4443755"/>
            <a:ext cx="56938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b="1" dirty="0"/>
              <a:t>Ε</a:t>
            </a:r>
            <a:r>
              <a:rPr lang="en-US" sz="2400" b="1" dirty="0"/>
              <a:t>.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51C0C9E-10BF-DE0F-7A3B-D7E24940735F}"/>
              </a:ext>
            </a:extLst>
          </p:cNvPr>
          <p:cNvSpPr txBox="1"/>
          <p:nvPr/>
        </p:nvSpPr>
        <p:spPr>
          <a:xfrm>
            <a:off x="674241" y="6123163"/>
            <a:ext cx="5822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b="1" dirty="0"/>
              <a:t>Ε</a:t>
            </a:r>
            <a:r>
              <a:rPr lang="en-US" sz="2400" b="1" dirty="0"/>
              <a:t>.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50E30EA-1A2B-0B8B-729F-196905CCB683}"/>
              </a:ext>
            </a:extLst>
          </p:cNvPr>
          <p:cNvSpPr txBox="1"/>
          <p:nvPr/>
        </p:nvSpPr>
        <p:spPr>
          <a:xfrm>
            <a:off x="4006144" y="4443755"/>
            <a:ext cx="5355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err="1"/>
              <a:t>F.a</a:t>
            </a:r>
            <a:endParaRPr lang="en-US" sz="24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3434FF2-5B02-BEA1-5C11-FDBFAA0219EC}"/>
              </a:ext>
            </a:extLst>
          </p:cNvPr>
          <p:cNvSpPr txBox="1"/>
          <p:nvPr/>
        </p:nvSpPr>
        <p:spPr>
          <a:xfrm>
            <a:off x="3982464" y="6123164"/>
            <a:ext cx="5484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err="1"/>
              <a:t>F.b</a:t>
            </a:r>
            <a:endParaRPr 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27151760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751C55B-E0B5-814B-964D-A27569F8D344}"/>
              </a:ext>
            </a:extLst>
          </p:cNvPr>
          <p:cNvSpPr txBox="1"/>
          <p:nvPr/>
        </p:nvSpPr>
        <p:spPr>
          <a:xfrm>
            <a:off x="-6723" y="-6708"/>
            <a:ext cx="15376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Supplementary Table 1</a:t>
            </a:r>
          </a:p>
        </p:txBody>
      </p:sp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0F7E4413-A231-C9A8-0440-89919776DE4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9663401"/>
              </p:ext>
            </p:extLst>
          </p:nvPr>
        </p:nvGraphicFramePr>
        <p:xfrm>
          <a:off x="63795" y="907312"/>
          <a:ext cx="7648356" cy="14389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12089">
                  <a:extLst>
                    <a:ext uri="{9D8B030D-6E8A-4147-A177-3AD203B41FA5}">
                      <a16:colId xmlns:a16="http://schemas.microsoft.com/office/drawing/2014/main" val="3801937675"/>
                    </a:ext>
                  </a:extLst>
                </a:gridCol>
                <a:gridCol w="1912089">
                  <a:extLst>
                    <a:ext uri="{9D8B030D-6E8A-4147-A177-3AD203B41FA5}">
                      <a16:colId xmlns:a16="http://schemas.microsoft.com/office/drawing/2014/main" val="1114932949"/>
                    </a:ext>
                  </a:extLst>
                </a:gridCol>
                <a:gridCol w="1912089">
                  <a:extLst>
                    <a:ext uri="{9D8B030D-6E8A-4147-A177-3AD203B41FA5}">
                      <a16:colId xmlns:a16="http://schemas.microsoft.com/office/drawing/2014/main" val="3313216958"/>
                    </a:ext>
                  </a:extLst>
                </a:gridCol>
                <a:gridCol w="1912089">
                  <a:extLst>
                    <a:ext uri="{9D8B030D-6E8A-4147-A177-3AD203B41FA5}">
                      <a16:colId xmlns:a16="http://schemas.microsoft.com/office/drawing/2014/main" val="1471958048"/>
                    </a:ext>
                  </a:extLst>
                </a:gridCol>
              </a:tblGrid>
              <a:tr h="71947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WT Mal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WT Femal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NF-</a:t>
                      </a:r>
                      <a:r>
                        <a:rPr lang="en-US" dirty="0" err="1"/>
                        <a:t>Tg</a:t>
                      </a:r>
                      <a:r>
                        <a:rPr lang="en-US" dirty="0"/>
                        <a:t> Mal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NF-</a:t>
                      </a:r>
                      <a:r>
                        <a:rPr lang="en-US" dirty="0" err="1"/>
                        <a:t>Tg</a:t>
                      </a:r>
                      <a:r>
                        <a:rPr lang="en-US" dirty="0"/>
                        <a:t> Femal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3864387"/>
                  </a:ext>
                </a:extLst>
              </a:tr>
              <a:tr h="71947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9/9/9/9/9/9/9/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9/9/8/8/8/8/8/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0/10/10/10/</a:t>
                      </a:r>
                    </a:p>
                    <a:p>
                      <a:pPr algn="ctr"/>
                      <a:r>
                        <a:rPr lang="en-US" dirty="0"/>
                        <a:t>10/10/10/1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4/14/14/14/</a:t>
                      </a:r>
                    </a:p>
                    <a:p>
                      <a:pPr algn="ctr"/>
                      <a:r>
                        <a:rPr lang="en-US" dirty="0"/>
                        <a:t>14/13/11/1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5281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034891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0E160287-444F-12F2-5FDB-632D73362F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8261200"/>
              </p:ext>
            </p:extLst>
          </p:nvPr>
        </p:nvGraphicFramePr>
        <p:xfrm>
          <a:off x="0" y="432390"/>
          <a:ext cx="7772400" cy="44515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70344">
                  <a:extLst>
                    <a:ext uri="{9D8B030D-6E8A-4147-A177-3AD203B41FA5}">
                      <a16:colId xmlns:a16="http://schemas.microsoft.com/office/drawing/2014/main" val="1318296593"/>
                    </a:ext>
                  </a:extLst>
                </a:gridCol>
                <a:gridCol w="837757">
                  <a:extLst>
                    <a:ext uri="{9D8B030D-6E8A-4147-A177-3AD203B41FA5}">
                      <a16:colId xmlns:a16="http://schemas.microsoft.com/office/drawing/2014/main" val="2589785587"/>
                    </a:ext>
                  </a:extLst>
                </a:gridCol>
                <a:gridCol w="837757">
                  <a:extLst>
                    <a:ext uri="{9D8B030D-6E8A-4147-A177-3AD203B41FA5}">
                      <a16:colId xmlns:a16="http://schemas.microsoft.com/office/drawing/2014/main" val="3743109633"/>
                    </a:ext>
                  </a:extLst>
                </a:gridCol>
                <a:gridCol w="837757">
                  <a:extLst>
                    <a:ext uri="{9D8B030D-6E8A-4147-A177-3AD203B41FA5}">
                      <a16:colId xmlns:a16="http://schemas.microsoft.com/office/drawing/2014/main" val="107091581"/>
                    </a:ext>
                  </a:extLst>
                </a:gridCol>
                <a:gridCol w="837757">
                  <a:extLst>
                    <a:ext uri="{9D8B030D-6E8A-4147-A177-3AD203B41FA5}">
                      <a16:colId xmlns:a16="http://schemas.microsoft.com/office/drawing/2014/main" val="1223234095"/>
                    </a:ext>
                  </a:extLst>
                </a:gridCol>
                <a:gridCol w="837757">
                  <a:extLst>
                    <a:ext uri="{9D8B030D-6E8A-4147-A177-3AD203B41FA5}">
                      <a16:colId xmlns:a16="http://schemas.microsoft.com/office/drawing/2014/main" val="1326256203"/>
                    </a:ext>
                  </a:extLst>
                </a:gridCol>
                <a:gridCol w="837757">
                  <a:extLst>
                    <a:ext uri="{9D8B030D-6E8A-4147-A177-3AD203B41FA5}">
                      <a16:colId xmlns:a16="http://schemas.microsoft.com/office/drawing/2014/main" val="1150184917"/>
                    </a:ext>
                  </a:extLst>
                </a:gridCol>
                <a:gridCol w="837757">
                  <a:extLst>
                    <a:ext uri="{9D8B030D-6E8A-4147-A177-3AD203B41FA5}">
                      <a16:colId xmlns:a16="http://schemas.microsoft.com/office/drawing/2014/main" val="864197310"/>
                    </a:ext>
                  </a:extLst>
                </a:gridCol>
                <a:gridCol w="837757">
                  <a:extLst>
                    <a:ext uri="{9D8B030D-6E8A-4147-A177-3AD203B41FA5}">
                      <a16:colId xmlns:a16="http://schemas.microsoft.com/office/drawing/2014/main" val="2993647244"/>
                    </a:ext>
                  </a:extLst>
                </a:gridCol>
              </a:tblGrid>
              <a:tr h="890300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dirty="0"/>
                        <a:t>Sedentary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dirty="0"/>
                        <a:t>Running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02591283"/>
                  </a:ext>
                </a:extLst>
              </a:tr>
              <a:tr h="89030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Outcome Measur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WT Mal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WT Femal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NF-</a:t>
                      </a:r>
                      <a:r>
                        <a:rPr lang="en-US" dirty="0" err="1"/>
                        <a:t>Tg</a:t>
                      </a:r>
                      <a:r>
                        <a:rPr lang="en-US" dirty="0"/>
                        <a:t> Mal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NF-</a:t>
                      </a:r>
                      <a:r>
                        <a:rPr lang="en-US" dirty="0" err="1"/>
                        <a:t>Tg</a:t>
                      </a:r>
                      <a:r>
                        <a:rPr lang="en-US" dirty="0"/>
                        <a:t> Femal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WT Mal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WT Femal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NF-</a:t>
                      </a:r>
                      <a:r>
                        <a:rPr lang="en-US" dirty="0" err="1"/>
                        <a:t>Tg</a:t>
                      </a:r>
                      <a:r>
                        <a:rPr lang="en-US" dirty="0"/>
                        <a:t> Mal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NF-</a:t>
                      </a:r>
                      <a:r>
                        <a:rPr lang="en-US" dirty="0" err="1"/>
                        <a:t>Tg</a:t>
                      </a:r>
                      <a:r>
                        <a:rPr lang="en-US" dirty="0"/>
                        <a:t> Femal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99224704"/>
                  </a:ext>
                </a:extLst>
              </a:tr>
              <a:tr h="89030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Lung Micro-CT</a:t>
                      </a:r>
                      <a:r>
                        <a:rPr lang="en-US" baseline="30000" dirty="0"/>
                        <a:t> a*</a:t>
                      </a:r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4/4/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5/5/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5/4/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8/8/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9834263"/>
                  </a:ext>
                </a:extLst>
              </a:tr>
              <a:tr h="89030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Ankle Micro-CT</a:t>
                      </a:r>
                      <a:r>
                        <a:rPr lang="en-US" baseline="30000" dirty="0"/>
                        <a:t> b</a:t>
                      </a:r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6/8/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14/10/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1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10/8/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1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14/16/1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9792337"/>
                  </a:ext>
                </a:extLst>
              </a:tr>
              <a:tr h="89030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Knee Micro-CT</a:t>
                      </a:r>
                      <a:r>
                        <a:rPr lang="en-US" baseline="30000" dirty="0"/>
                        <a:t> b</a:t>
                      </a:r>
                      <a:r>
                        <a:rPr lang="en-US" dirty="0"/>
                        <a:t>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1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1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1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1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3008673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F05EF6C-4FC3-5172-6ECE-500465D58B21}"/>
              </a:ext>
            </a:extLst>
          </p:cNvPr>
          <p:cNvSpPr txBox="1"/>
          <p:nvPr/>
        </p:nvSpPr>
        <p:spPr>
          <a:xfrm>
            <a:off x="-6723" y="-6708"/>
            <a:ext cx="15376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Supplementary Table 2</a:t>
            </a:r>
          </a:p>
        </p:txBody>
      </p:sp>
    </p:spTree>
    <p:extLst>
      <p:ext uri="{BB962C8B-B14F-4D97-AF65-F5344CB8AC3E}">
        <p14:creationId xmlns:p14="http://schemas.microsoft.com/office/powerpoint/2010/main" val="867386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88</TotalTime>
  <Words>306</Words>
  <Application>Microsoft Office PowerPoint</Application>
  <PresentationFormat>Custom</PresentationFormat>
  <Paragraphs>7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Supplementary Figures Implementation of Automated Behavior Metrics to Evaluate Voluntary Wheel Running Effects on Inflammatory-Erosive Arthritis and Interstitial Lung Disease in TNF-Tg M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ward Kenney</dc:creator>
  <cp:lastModifiedBy>Kenney, Mark (Howard)​</cp:lastModifiedBy>
  <cp:revision>210</cp:revision>
  <dcterms:created xsi:type="dcterms:W3CDTF">2021-03-28T22:59:20Z</dcterms:created>
  <dcterms:modified xsi:type="dcterms:W3CDTF">2022-12-08T15:48:57Z</dcterms:modified>
</cp:coreProperties>
</file>